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4" r:id="rId3"/>
    <p:sldId id="267" r:id="rId4"/>
    <p:sldId id="265" r:id="rId5"/>
    <p:sldId id="266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FC3F6D-C0AB-297F-31EA-AD32002A233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B943F80-0E2C-5EB2-7C62-208C3BBD43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D99E83-5945-3FE8-9FE1-85DDD094D8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372000-8F48-0C9E-63AB-014751047B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928AA8-0A09-A84D-C9CB-7B3A705339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46024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FB316F-5824-66AD-BDE6-60538CAE2D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1EFB51-CFF6-FC6D-B828-3FCA2E7B7F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FFB28D-BF77-5AE1-AB98-B1604A8024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A4227E-9EEC-CB68-6508-D12EE3CDC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CDF7F4-3053-2991-D6F5-ECB04C883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27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1691218-A532-93B8-0A7D-4C9A8A76C5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FF26CE-79D3-21F9-766B-69E678E316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6408F1-FC4C-316F-22A4-5DA3A5DB3F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71B1F5-F2A6-C6A3-9219-547A97E79A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918633-3FAF-5E91-E3C1-0D4E3B9B96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142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DB7B0A-AEC3-10C2-8D22-B938F5B25B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31D525-8AB1-4AAA-39E8-B0C61A2D6A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A391D-8A51-2885-C931-0DB3066D80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8A82E8-C088-8B32-7273-9781997AB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2078AD-F612-7EA5-98BA-95A723E42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2698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A15806-3162-714D-EA17-30C61437B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A4712D-E365-CC19-6480-82DC1ABDD9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55AD97-2576-954B-C429-7A3CAACC37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37FF35-94A9-5DEB-FAAE-934C3E718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F69AB4-B2DF-BD21-E205-C3BE751C4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0453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48FC6C-4612-2BB3-F0F2-16A7E74F39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7F4AD8A-B5B0-9F02-9ABD-1FF1DE647D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BA0FB0-AF62-CB47-4402-25B4B8CE89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1158BFC-481B-5770-5CF1-520B5264C3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5DE748D-190D-18E5-34B8-CAA04A9F3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48A54F-46B2-3884-CC7F-1DCCF16C9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65538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3E24EF-70DC-DBF8-7FC0-E3446178EE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9D791E5-1E0C-F293-BC11-0491B768BB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10C323-163A-DD02-7AEB-DB31C71B989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065E0C8-4C6D-FFE3-C9DA-7ADDABA706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B63F739-BB7C-75E2-6835-1E705D069E6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C3F715-5DC9-6665-8BB2-6AF67B58FE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CBDC2A0-D01C-7F94-F8D4-B00978DA5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1E5A591-F7F4-7FAD-408D-2C0A24D92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2797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940EE-FC5E-95F0-1B2E-F46095BEDB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83A35CA-FC74-8D12-68EF-701AB61CD3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839BC46-F147-F265-E012-717678788D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B7AE9C-94DA-30E0-6178-56EAD10FCF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963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3DEF45-424A-7AE6-3126-AB4473971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34FEA6E-71E1-E860-E931-E819067FB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62E94C8-258D-EDC3-09E4-D5DD9DAC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087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BC7129-3DC9-A3A6-B167-7217F3368F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0F6F39-5CC6-D761-2E22-9B8C232414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ADF04E-3EF3-5C2A-FFD0-D10A2558288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D6BF68B-7D74-67F6-559A-2E3A798FF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7B53C2-FE92-E2BA-1EB8-047CD642B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8A62F8-4276-BDE1-1B23-D8448E883D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9692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B1937-9068-1646-DA40-D38CB9BAE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DE04516-3343-4D59-7990-D0D8E80C4B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201C730-9C8E-AE4E-1672-77358B74D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236AD0-2C94-82B4-34A7-5B3E4EDBE6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87C3B8-667F-7530-1F71-848281C5F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1A565C-A953-2746-FAC8-5DE97F245F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239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D992288-B492-1DA5-1513-625422F074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FF10B2-B48E-76EB-8CCD-919C7FA299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235F16-4C20-B4E9-26EB-B009B44ABD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941030-A2C0-47DE-9EF5-25B47202F465}" type="datetimeFigureOut">
              <a:rPr lang="en-US" smtClean="0"/>
              <a:t>7/22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C1B094-2B9A-8884-0919-C37712333F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720765-77B7-5656-2189-5163FE6A56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C47D0B-F512-4F46-BB34-AE4F88C428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6345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F2DD9057-0E38-5A90-BBF8-DCA793C06F2E}"/>
              </a:ext>
            </a:extLst>
          </p:cNvPr>
          <p:cNvGrpSpPr/>
          <p:nvPr/>
        </p:nvGrpSpPr>
        <p:grpSpPr>
          <a:xfrm>
            <a:off x="3422672" y="2187024"/>
            <a:ext cx="5415292" cy="2211324"/>
            <a:chOff x="3422672" y="2187024"/>
            <a:chExt cx="5415292" cy="2211324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35039A1E-A2A3-B6AF-03C3-F109A4D7593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22672" y="2459652"/>
              <a:ext cx="5346655" cy="1938696"/>
            </a:xfrm>
            <a:prstGeom prst="rect">
              <a:avLst/>
            </a:prstGeom>
          </p:spPr>
        </p:pic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640DA308-41BE-D21A-2613-2FB97889D46E}"/>
                </a:ext>
              </a:extLst>
            </p:cNvPr>
            <p:cNvSpPr txBox="1"/>
            <p:nvPr/>
          </p:nvSpPr>
          <p:spPr>
            <a:xfrm flipH="1">
              <a:off x="3491309" y="2201039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1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F274419-BC68-521E-5A3D-97D8D3CCF96A}"/>
                </a:ext>
              </a:extLst>
            </p:cNvPr>
            <p:cNvSpPr txBox="1"/>
            <p:nvPr/>
          </p:nvSpPr>
          <p:spPr>
            <a:xfrm flipH="1">
              <a:off x="6653279" y="2197783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7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1488878-8843-1CE9-1D7F-9F79DAEC21E3}"/>
                </a:ext>
              </a:extLst>
            </p:cNvPr>
            <p:cNvSpPr txBox="1"/>
            <p:nvPr/>
          </p:nvSpPr>
          <p:spPr>
            <a:xfrm flipH="1">
              <a:off x="6133086" y="2197782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6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8FF6C2C-0016-9021-226F-77736A6CE55B}"/>
                </a:ext>
              </a:extLst>
            </p:cNvPr>
            <p:cNvSpPr txBox="1"/>
            <p:nvPr/>
          </p:nvSpPr>
          <p:spPr>
            <a:xfrm flipH="1">
              <a:off x="4087733" y="2201039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2EB7068-0378-D404-ADA6-6811C8209177}"/>
                </a:ext>
              </a:extLst>
            </p:cNvPr>
            <p:cNvSpPr txBox="1"/>
            <p:nvPr/>
          </p:nvSpPr>
          <p:spPr>
            <a:xfrm flipH="1">
              <a:off x="4604022" y="2195346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3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E037E0C0-028E-E928-4721-B87994EDF3C4}"/>
                </a:ext>
              </a:extLst>
            </p:cNvPr>
            <p:cNvSpPr txBox="1"/>
            <p:nvPr/>
          </p:nvSpPr>
          <p:spPr>
            <a:xfrm flipH="1">
              <a:off x="5120311" y="2189749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1BD244E-EC8C-7D89-6280-8920B016164C}"/>
                </a:ext>
              </a:extLst>
            </p:cNvPr>
            <p:cNvSpPr txBox="1"/>
            <p:nvPr/>
          </p:nvSpPr>
          <p:spPr>
            <a:xfrm flipH="1">
              <a:off x="5612893" y="2195032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5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0DB9D37-59AE-A9A1-E303-53567925A2E2}"/>
                </a:ext>
              </a:extLst>
            </p:cNvPr>
            <p:cNvSpPr txBox="1"/>
            <p:nvPr/>
          </p:nvSpPr>
          <p:spPr>
            <a:xfrm flipH="1">
              <a:off x="7639323" y="2189749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9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DE2F0D31-7847-F5A1-D8B6-9441DA94DE8E}"/>
                </a:ext>
              </a:extLst>
            </p:cNvPr>
            <p:cNvSpPr txBox="1"/>
            <p:nvPr/>
          </p:nvSpPr>
          <p:spPr>
            <a:xfrm flipH="1">
              <a:off x="7136822" y="2187024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8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6046D1E-6031-C3BB-6A0C-12F32C82AEF1}"/>
                </a:ext>
              </a:extLst>
            </p:cNvPr>
            <p:cNvSpPr txBox="1"/>
            <p:nvPr/>
          </p:nvSpPr>
          <p:spPr>
            <a:xfrm flipH="1">
              <a:off x="8152163" y="2189749"/>
              <a:ext cx="6858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Lane 10</a:t>
              </a:r>
            </a:p>
          </p:txBody>
        </p:sp>
      </p:grp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8BCCAF28-8B66-4BCB-B3B4-88B6AE0DA849}"/>
              </a:ext>
            </a:extLst>
          </p:cNvPr>
          <p:cNvCxnSpPr>
            <a:cxnSpLocks/>
          </p:cNvCxnSpPr>
          <p:nvPr/>
        </p:nvCxnSpPr>
        <p:spPr>
          <a:xfrm flipH="1">
            <a:off x="8659519" y="3646968"/>
            <a:ext cx="3804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A9C40F5C-65FB-435D-7A7A-7A4B131EC65E}"/>
              </a:ext>
            </a:extLst>
          </p:cNvPr>
          <p:cNvCxnSpPr>
            <a:cxnSpLocks/>
          </p:cNvCxnSpPr>
          <p:nvPr/>
        </p:nvCxnSpPr>
        <p:spPr>
          <a:xfrm flipH="1">
            <a:off x="8632320" y="3278372"/>
            <a:ext cx="3804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CC4247A0-E9AE-754E-E0DE-625B23EA9EBF}"/>
              </a:ext>
            </a:extLst>
          </p:cNvPr>
          <p:cNvCxnSpPr>
            <a:cxnSpLocks/>
          </p:cNvCxnSpPr>
          <p:nvPr/>
        </p:nvCxnSpPr>
        <p:spPr>
          <a:xfrm flipH="1">
            <a:off x="8632320" y="3090530"/>
            <a:ext cx="3804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63AC30D6-8E23-D073-0F0F-F95DC8C97715}"/>
              </a:ext>
            </a:extLst>
          </p:cNvPr>
          <p:cNvCxnSpPr>
            <a:cxnSpLocks/>
          </p:cNvCxnSpPr>
          <p:nvPr/>
        </p:nvCxnSpPr>
        <p:spPr>
          <a:xfrm flipH="1">
            <a:off x="8632320" y="2966484"/>
            <a:ext cx="3804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9859B0E3-C482-8420-8B15-768B9D8D6220}"/>
              </a:ext>
            </a:extLst>
          </p:cNvPr>
          <p:cNvCxnSpPr>
            <a:cxnSpLocks/>
          </p:cNvCxnSpPr>
          <p:nvPr/>
        </p:nvCxnSpPr>
        <p:spPr>
          <a:xfrm flipH="1">
            <a:off x="8648886" y="2874335"/>
            <a:ext cx="380464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4F05F60-C545-4FAA-4D3B-72BD549EC469}"/>
              </a:ext>
            </a:extLst>
          </p:cNvPr>
          <p:cNvSpPr txBox="1"/>
          <p:nvPr/>
        </p:nvSpPr>
        <p:spPr>
          <a:xfrm>
            <a:off x="8991518" y="3500984"/>
            <a:ext cx="659219" cy="2616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500 bp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C4530DF-ABD8-0848-1654-287824DC4315}"/>
              </a:ext>
            </a:extLst>
          </p:cNvPr>
          <p:cNvSpPr txBox="1"/>
          <p:nvPr/>
        </p:nvSpPr>
        <p:spPr>
          <a:xfrm>
            <a:off x="8952448" y="2727012"/>
            <a:ext cx="659219" cy="2616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3000 b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78E00E82-2F57-7A97-98FC-6CC8BCDD34A4}"/>
              </a:ext>
            </a:extLst>
          </p:cNvPr>
          <p:cNvSpPr txBox="1"/>
          <p:nvPr/>
        </p:nvSpPr>
        <p:spPr>
          <a:xfrm>
            <a:off x="8945360" y="2838222"/>
            <a:ext cx="659219" cy="2616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2000 b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D4DEDC3-5A66-EA51-AB42-787C7D683844}"/>
              </a:ext>
            </a:extLst>
          </p:cNvPr>
          <p:cNvSpPr txBox="1"/>
          <p:nvPr/>
        </p:nvSpPr>
        <p:spPr>
          <a:xfrm>
            <a:off x="8966707" y="2969023"/>
            <a:ext cx="659219" cy="2616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1500 bp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A8F7057-3AC6-2F0D-31A4-3B16F5259708}"/>
              </a:ext>
            </a:extLst>
          </p:cNvPr>
          <p:cNvSpPr txBox="1"/>
          <p:nvPr/>
        </p:nvSpPr>
        <p:spPr>
          <a:xfrm>
            <a:off x="8966708" y="3153988"/>
            <a:ext cx="6592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1000 b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40C2F39-F9E9-E929-F1CD-921E58C1878A}"/>
              </a:ext>
            </a:extLst>
          </p:cNvPr>
          <p:cNvSpPr txBox="1"/>
          <p:nvPr/>
        </p:nvSpPr>
        <p:spPr>
          <a:xfrm>
            <a:off x="973614" y="5083898"/>
            <a:ext cx="9664995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1.  PCR amplification with primers to identify wildtype genes alleles and deletion mutant alleles.  Lanes 5 and 10 contain DNA size markers.  Lanes 1 &amp; 2: ∆NCU05137 deletion mutant genomic DNA amplified for the deletion mutation (lane 1) and for the wildtype allele (lane 2).  Lanes 3 &amp; 4: genomic DNA from a ∆NCU05137 heterokaryon amplified for the deletion mutation (lane 3) and for the wildtype allele (lane 4).  Lanes 6 &amp; 7: genomic DNA from a hygromycin-resistant homokaryotic progeny derived from ∆NCU05136 (heterokaryon) amplified for the deletion mutation (lane 6) and for the wildtype allele (lane 7).   Lanes 8 &amp; 9: ∆NCU05132 deletion mutant genomic DNA amplified for deletion mutation (lane 8) and for wildtype allele (lane 9).</a:t>
            </a:r>
          </a:p>
        </p:txBody>
      </p:sp>
    </p:spTree>
    <p:extLst>
      <p:ext uri="{BB962C8B-B14F-4D97-AF65-F5344CB8AC3E}">
        <p14:creationId xmlns:p14="http://schemas.microsoft.com/office/powerpoint/2010/main" val="38498475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467A154-8CDC-0726-6086-CE124BD75D5E}"/>
              </a:ext>
            </a:extLst>
          </p:cNvPr>
          <p:cNvSpPr txBox="1"/>
          <p:nvPr/>
        </p:nvSpPr>
        <p:spPr>
          <a:xfrm>
            <a:off x="3046827" y="5571063"/>
            <a:ext cx="6098344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Figure S2: Penetrometer apparatus used to take measurement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4C623D24-7201-5B35-5EAC-AB60BA436D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0852" y="414371"/>
            <a:ext cx="3854784" cy="47917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067876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 xmlns:a14="http://schemas.microsoft.com/office/drawing/2010/main">
        <mc:Choice Requires="a14"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F3DA4C48-947F-3A94-0588-A686A8F2B1BB}"/>
                  </a:ext>
                </a:extLst>
              </p:cNvPr>
              <p:cNvSpPr txBox="1"/>
              <p:nvPr/>
            </p:nvSpPr>
            <p:spPr>
              <a:xfrm>
                <a:off x="2283657" y="4296624"/>
                <a:ext cx="8073444" cy="92333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Figure S3. Microscopic images of hyphae binding to the chitin particulates.  (A)</a:t>
                </a:r>
                <a:r>
                  <a:rPr kumimoji="0" lang="en-US" sz="1800" b="0" i="0" u="none" strike="noStrike" kern="1200" cap="none" spc="0" normalizeH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wildtype hyphae do not bind the chitin particulates.  (</a:t>
                </a:r>
                <a:r>
                  <a:rPr kumimoji="0" 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B) </a:t>
                </a:r>
                <a14:m>
                  <m:oMath xmlns:m="http://schemas.openxmlformats.org/officeDocument/2006/math">
                    <m:r>
                      <a:rPr kumimoji="0" lang="en-US" sz="1800" b="0" i="1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mbria Math" panose="02040503050406030204" pitchFamily="18" charset="0"/>
                        <a:ea typeface="Cambria Math" panose="02040503050406030204" pitchFamily="18" charset="0"/>
                        <a:cs typeface="+mn-cs"/>
                      </a:rPr>
                      <m:t>∆</m:t>
                    </m:r>
                  </m:oMath>
                </a14:m>
                <a:r>
                  <a:rPr kumimoji="0" 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CU05137 (GAG deacetylase mutant) bind</a:t>
                </a:r>
                <a:r>
                  <a:rPr kumimoji="0" lang="en-US" sz="1800" b="0" i="0" u="none" strike="noStrike" kern="1200" cap="none" spc="0" normalizeH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chitin particulates</a:t>
                </a:r>
                <a:r>
                  <a:rPr kumimoji="0" lang="en-US" sz="18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.</a:t>
                </a:r>
              </a:p>
            </p:txBody>
          </p:sp>
        </mc:Choice>
        <mc:Fallback xmlns="">
          <p:sp>
            <p:nvSpPr>
              <p:cNvPr id="3" name="TextBox 2">
                <a:extLst>
                  <a:ext uri="{FF2B5EF4-FFF2-40B4-BE49-F238E27FC236}">
                    <a16:creationId xmlns:a16="http://schemas.microsoft.com/office/drawing/2014/main" id="{F3DA4C48-947F-3A94-0588-A686A8F2B1B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283657" y="4296624"/>
                <a:ext cx="8073444" cy="923330"/>
              </a:xfrm>
              <a:prstGeom prst="rect">
                <a:avLst/>
              </a:prstGeom>
              <a:blipFill>
                <a:blip r:embed="rId2"/>
                <a:stretch>
                  <a:fillRect l="-680" t="-3974" b="-993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grpSp>
        <p:nvGrpSpPr>
          <p:cNvPr id="10" name="Group 9">
            <a:extLst>
              <a:ext uri="{FF2B5EF4-FFF2-40B4-BE49-F238E27FC236}">
                <a16:creationId xmlns:a16="http://schemas.microsoft.com/office/drawing/2014/main" id="{33B98E89-D744-E02D-50BB-052150714E75}"/>
              </a:ext>
            </a:extLst>
          </p:cNvPr>
          <p:cNvGrpSpPr/>
          <p:nvPr/>
        </p:nvGrpSpPr>
        <p:grpSpPr>
          <a:xfrm>
            <a:off x="2277565" y="1117712"/>
            <a:ext cx="7962304" cy="2981964"/>
            <a:chOff x="2277565" y="1117712"/>
            <a:chExt cx="7962304" cy="2981964"/>
          </a:xfrm>
        </p:grpSpPr>
        <p:pic>
          <p:nvPicPr>
            <p:cNvPr id="5" name="Picture 4" descr="A close-up of a microscope&#10;&#10;Description automatically generated">
              <a:extLst>
                <a:ext uri="{FF2B5EF4-FFF2-40B4-BE49-F238E27FC236}">
                  <a16:creationId xmlns:a16="http://schemas.microsoft.com/office/drawing/2014/main" id="{A62FD801-681F-BAC6-3AE8-9A049258604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64809" y="1118381"/>
              <a:ext cx="3975060" cy="2981295"/>
            </a:xfrm>
            <a:prstGeom prst="rect">
              <a:avLst/>
            </a:prstGeom>
          </p:spPr>
        </p:pic>
        <p:pic>
          <p:nvPicPr>
            <p:cNvPr id="7" name="Picture 6" descr="Close-up of a blue background&#10;&#10;Description automatically generated">
              <a:extLst>
                <a:ext uri="{FF2B5EF4-FFF2-40B4-BE49-F238E27FC236}">
                  <a16:creationId xmlns:a16="http://schemas.microsoft.com/office/drawing/2014/main" id="{0187B82B-4AF3-8CD6-9857-89F1A12AD9D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96909" y="1118380"/>
              <a:ext cx="3975060" cy="298129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98289CC-71D1-561F-5C72-708EFDC76A7A}"/>
                </a:ext>
              </a:extLst>
            </p:cNvPr>
            <p:cNvSpPr txBox="1"/>
            <p:nvPr/>
          </p:nvSpPr>
          <p:spPr>
            <a:xfrm>
              <a:off x="2277565" y="1117712"/>
              <a:ext cx="29670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  <a:latin typeface="+mj-lt"/>
                </a:rPr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BC82C7C-A14C-6F57-37FB-337B9AF0B731}"/>
                </a:ext>
              </a:extLst>
            </p:cNvPr>
            <p:cNvSpPr txBox="1"/>
            <p:nvPr/>
          </p:nvSpPr>
          <p:spPr>
            <a:xfrm>
              <a:off x="6258717" y="1117712"/>
              <a:ext cx="4785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  <a:latin typeface="+mj-lt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1042657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7085B25A-7A07-6F6F-2631-834CD076E711}"/>
              </a:ext>
            </a:extLst>
          </p:cNvPr>
          <p:cNvGrpSpPr/>
          <p:nvPr/>
        </p:nvGrpSpPr>
        <p:grpSpPr>
          <a:xfrm>
            <a:off x="2280683" y="1690688"/>
            <a:ext cx="7313696" cy="2819499"/>
            <a:chOff x="2280683" y="1690688"/>
            <a:chExt cx="7313696" cy="281949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2FFD376B-7579-D5FD-19F5-2FA1AA63267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951389" y="1715483"/>
              <a:ext cx="3642990" cy="2794704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25BDE59-E4BA-DB3F-BBF3-EEDCFFAA62C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0800000" flipH="1">
              <a:off x="2305879" y="1715482"/>
              <a:ext cx="3642990" cy="2794704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E7FA55F-4ECB-56FC-61C2-3806CB80A6EE}"/>
                </a:ext>
              </a:extLst>
            </p:cNvPr>
            <p:cNvSpPr txBox="1"/>
            <p:nvPr/>
          </p:nvSpPr>
          <p:spPr>
            <a:xfrm>
              <a:off x="2280683" y="1690688"/>
              <a:ext cx="2694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  <a:latin typeface="+mj-lt"/>
                </a:rPr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15048DF-50E9-13AE-0383-545868BBBEE1}"/>
                </a:ext>
              </a:extLst>
            </p:cNvPr>
            <p:cNvSpPr txBox="1"/>
            <p:nvPr/>
          </p:nvSpPr>
          <p:spPr>
            <a:xfrm>
              <a:off x="5935616" y="1690688"/>
              <a:ext cx="2694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  <a:latin typeface="+mj-lt"/>
                </a:rPr>
                <a:t>B</a:t>
              </a:r>
            </a:p>
          </p:txBody>
        </p: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DDCBF7B-FF02-7D77-56FA-277BAA04874B}"/>
                  </a:ext>
                </a:extLst>
              </p:cNvPr>
              <p:cNvSpPr txBox="1"/>
              <p:nvPr/>
            </p:nvSpPr>
            <p:spPr>
              <a:xfrm>
                <a:off x="2120348" y="4648561"/>
                <a:ext cx="7474031" cy="83099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lvl="0">
                  <a:defRPr/>
                </a:pPr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Figure S4. Microscopic images of mutants  hyphae binding to the particulates.  (A) </a:t>
                </a:r>
                <a14:m>
                  <m:oMath xmlns:m="http://schemas.openxmlformats.org/officeDocument/2006/math">
                    <m:r>
                      <a:rPr kumimoji="0" lang="en-US" sz="1600" b="0" i="1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mbria Math" panose="02040503050406030204" pitchFamily="18" charset="0"/>
                        <a:ea typeface="Cambria Math" panose="02040503050406030204" pitchFamily="18" charset="0"/>
                        <a:cs typeface="+mn-cs"/>
                      </a:rPr>
                      <m:t>∆</m:t>
                    </m:r>
                  </m:oMath>
                </a14:m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CU05132 (GAG synthase mutant) hyphae do not bind the activated charcoal.  (B</a:t>
                </a:r>
                <a:r>
                  <a:rPr lang="en-US" sz="1600" dirty="0">
                    <a:solidFill>
                      <a:prstClr val="black"/>
                    </a:solidFill>
                    <a:latin typeface="Calibri" panose="020F0502020204030204"/>
                  </a:rPr>
                  <a:t>)</a:t>
                </a:r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14:m>
                  <m:oMath xmlns:m="http://schemas.openxmlformats.org/officeDocument/2006/math">
                    <m:r>
                      <a:rPr kumimoji="0" lang="en-US" sz="1600" b="0" i="1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mbria Math" panose="02040503050406030204" pitchFamily="18" charset="0"/>
                        <a:ea typeface="Cambria Math" panose="02040503050406030204" pitchFamily="18" charset="0"/>
                        <a:cs typeface="+mn-cs"/>
                      </a:rPr>
                      <m:t>∆</m:t>
                    </m:r>
                  </m:oMath>
                </a14:m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CU05137 (GAG deacetylase mutant) hyphae bind the activated charcoal.</a:t>
                </a:r>
                <a:r>
                  <a:rPr kumimoji="0" lang="en-US" sz="1600" b="0" i="0" u="none" strike="noStrike" kern="1200" cap="none" spc="0" normalizeH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 </a:t>
                </a:r>
                <a:endParaRPr kumimoji="0" lang="en-US" sz="16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</mc:Choice>
        <mc:Fallback xmlns=""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EDDCBF7B-FF02-7D77-56FA-277BAA04874B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2120348" y="4648561"/>
                <a:ext cx="7474031" cy="830997"/>
              </a:xfrm>
              <a:prstGeom prst="rect">
                <a:avLst/>
              </a:prstGeom>
              <a:blipFill>
                <a:blip r:embed="rId4"/>
                <a:stretch>
                  <a:fillRect l="-489" t="-2206" b="-8824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4365538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227A70CB-0969-77E3-3F3C-11E053DF7D61}"/>
              </a:ext>
            </a:extLst>
          </p:cNvPr>
          <p:cNvGrpSpPr/>
          <p:nvPr/>
        </p:nvGrpSpPr>
        <p:grpSpPr>
          <a:xfrm>
            <a:off x="3122749" y="1740820"/>
            <a:ext cx="6474705" cy="2517340"/>
            <a:chOff x="3122749" y="1740820"/>
            <a:chExt cx="6474705" cy="2517340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5B546D90-4E81-CEAC-7244-9C1131FEB88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51163" y="1780879"/>
              <a:ext cx="3222998" cy="2477281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F14021F-D9B9-3B11-8F88-D9ADE4CCC23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74456" y="1780879"/>
              <a:ext cx="3222998" cy="2477281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89805ABC-FC2E-72C7-BFDB-3F01D9A90A17}"/>
                </a:ext>
              </a:extLst>
            </p:cNvPr>
            <p:cNvSpPr txBox="1"/>
            <p:nvPr/>
          </p:nvSpPr>
          <p:spPr>
            <a:xfrm>
              <a:off x="3122749" y="1771753"/>
              <a:ext cx="351972" cy="3806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solidFill>
                    <a:srgbClr val="FF0000"/>
                  </a:solidFill>
                  <a:latin typeface="+mj-lt"/>
                </a:rPr>
                <a:t>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E7D3673-B3B4-2E52-E6B4-85334C3E36DF}"/>
                </a:ext>
              </a:extLst>
            </p:cNvPr>
            <p:cNvSpPr txBox="1"/>
            <p:nvPr/>
          </p:nvSpPr>
          <p:spPr>
            <a:xfrm>
              <a:off x="6333735" y="1740820"/>
              <a:ext cx="4785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>
                  <a:solidFill>
                    <a:srgbClr val="FF0000"/>
                  </a:solidFill>
                  <a:latin typeface="+mj-lt"/>
                </a:rPr>
                <a:t>B</a:t>
              </a:r>
            </a:p>
          </p:txBody>
        </p:sp>
      </p:grpSp>
      <mc:AlternateContent xmlns:mc="http://schemas.openxmlformats.org/markup-compatibility/2006" xmlns:a14="http://schemas.microsoft.com/office/drawing/2010/main">
        <mc:Choice Requires="a14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49806E9-D651-0CB5-E14D-CE160CD2A692}"/>
                  </a:ext>
                </a:extLst>
              </p:cNvPr>
              <p:cNvSpPr txBox="1"/>
              <p:nvPr/>
            </p:nvSpPr>
            <p:spPr>
              <a:xfrm>
                <a:off x="3122748" y="4298219"/>
                <a:ext cx="6617599" cy="107721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Figure S5. Microscopic images of mutants  hyphae binding to the wheat grass particulates.  (A) </a:t>
                </a:r>
                <a14:m>
                  <m:oMath xmlns:m="http://schemas.openxmlformats.org/officeDocument/2006/math">
                    <m:r>
                      <a:rPr kumimoji="0" lang="en-US" sz="1600" b="0" i="1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mbria Math" panose="02040503050406030204" pitchFamily="18" charset="0"/>
                        <a:ea typeface="Cambria Math" panose="02040503050406030204" pitchFamily="18" charset="0"/>
                        <a:cs typeface="+mn-cs"/>
                      </a:rPr>
                      <m:t>∆</m:t>
                    </m:r>
                  </m:oMath>
                </a14:m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CU05132 (GAG synthase mutant) hyphae do not bind the wheat grass.  (B) </a:t>
                </a:r>
                <a14:m>
                  <m:oMath xmlns:m="http://schemas.openxmlformats.org/officeDocument/2006/math">
                    <m:r>
                      <a:rPr kumimoji="0" lang="en-US" sz="1600" b="0" i="1" u="none" strike="noStrike" kern="1200" cap="none" spc="0" normalizeH="0" baseline="0" noProof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mbria Math" panose="02040503050406030204" pitchFamily="18" charset="0"/>
                        <a:ea typeface="Cambria Math" panose="02040503050406030204" pitchFamily="18" charset="0"/>
                        <a:cs typeface="+mn-cs"/>
                      </a:rPr>
                      <m:t>∆</m:t>
                    </m:r>
                  </m:oMath>
                </a14:m>
                <a:r>
                  <a:rPr kumimoji="0" lang="en-US" sz="1600" b="0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 panose="020F0502020204030204"/>
                    <a:ea typeface="+mn-ea"/>
                    <a:cs typeface="+mn-cs"/>
                  </a:rPr>
                  <a:t>NCU05137 (GAG deacetylase mutant) hyphae bind the wheat grass particulates.</a:t>
                </a:r>
              </a:p>
            </p:txBody>
          </p:sp>
        </mc:Choice>
        <mc:Fallback xmlns=""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849806E9-D651-0CB5-E14D-CE160CD2A692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122748" y="4298219"/>
                <a:ext cx="6617599" cy="1077218"/>
              </a:xfrm>
              <a:prstGeom prst="rect">
                <a:avLst/>
              </a:prstGeom>
              <a:blipFill>
                <a:blip r:embed="rId4"/>
                <a:stretch>
                  <a:fillRect l="-460" t="-1695" b="-6215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</p:spTree>
    <p:extLst>
      <p:ext uri="{BB962C8B-B14F-4D97-AF65-F5344CB8AC3E}">
        <p14:creationId xmlns:p14="http://schemas.microsoft.com/office/powerpoint/2010/main" val="1651178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331</Words>
  <Application>Microsoft Office PowerPoint</Application>
  <PresentationFormat>Widescreen</PresentationFormat>
  <Paragraphs>2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Cambria Math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at Buffal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Free</dc:creator>
  <cp:lastModifiedBy>Stephen Free</cp:lastModifiedBy>
  <cp:revision>2</cp:revision>
  <dcterms:created xsi:type="dcterms:W3CDTF">2024-07-15T19:10:40Z</dcterms:created>
  <dcterms:modified xsi:type="dcterms:W3CDTF">2024-07-22T14:16:28Z</dcterms:modified>
</cp:coreProperties>
</file>